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3CBE8-32B1-4B3F-BDD2-7B27BE7F37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6545CB-6BD1-420E-8C7A-6A41495B10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553A7-D68D-4048-9E3B-5CDEAB7DC3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B705F8-8B21-40A7-AA63-89EE3FCB0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8324B8-CDE1-4075-9D9D-F296414907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53669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D2C80-CF72-4AD1-8AEB-645C1A498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77DA84-D9ED-4A90-9BE6-0B402C70C4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EB446B-4166-4952-94B2-FB4ADE721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E3411A-F498-4ADD-854D-8430DC3E6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4C467-A2F7-4CAA-B28C-05424994D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3211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35DFF0-93FD-46FF-9D1E-F400A975C0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01A5C7-7DDB-490E-A551-7009A7C1F7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69A68-3055-4DD5-BFD7-77AAFA0E6F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0D6364-83FE-4EB8-8A80-36289F65C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732EE2-7BE8-459D-A54B-199A104FB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211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1B500-84C6-4D49-824E-9967D51BAE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EE8915-2041-43BA-9BE2-F0A36DDB76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75F51C-1458-4B57-83AC-F21867EC9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8F65BF-DADF-4F2B-AE0B-8D1922220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1CC60D-F0A5-4D57-BB15-07A87DE1F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9774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9B101-E175-4FDB-A048-C2BE8C8AE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14F478-1B96-4F14-8B20-F7F945A972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9CA6B7-409A-4230-9C60-34E930FEB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A42CA0-92DF-4742-83DF-3FE51532F0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BD63E-3717-4786-82DC-0D1A4E2814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9584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8D092D-97E1-4CE1-88A4-B64A41EE4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6F1A54-36FE-4ADF-BCDD-2DB38C9300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DB2399-B673-49CC-883C-3691BCDE05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BE7AB2-4AD1-480A-B1D2-6E4021F78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C2FD76-F271-4787-AA9C-3A4F4E1513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7E43CD-E014-488C-BDD9-0717D682A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785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5FB3E6-61B4-42AA-A5D7-321953F59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1FB330-BE6F-4CD5-8CED-98EC0B5747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F38A22-4C00-4AC5-AC51-C3EDC955B0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5E81E9C-0042-408C-80D2-7132F1C3248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4C6835-AF20-440A-94E7-866A44D1BE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ECFCE8A-4EE2-4AA1-BE1C-8845ACA000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405485D-A87E-457F-84B6-9AEEC5C27C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173719-8DAD-4CC5-B3E0-2B87A77EF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9481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A429A7-1ACF-45D2-A334-135AAE695A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2A14BA-577D-4934-8D63-ECFEE80C0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19E9DB-2EEB-4046-BAA3-B50B9EAB7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9A7237-E707-4C00-829C-0A030ECD30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2231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E9C0305-4741-4E86-9766-C836DFC0B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CBF3EA6-8ACF-4A6F-8DC7-C232C8D87F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50D4FA-4E7C-45EB-86BE-0F8BF68E2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2847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596B04-706A-4248-A9F1-968E875E19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68360A-7C72-42C7-B9BA-B1DD5295CF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98871F-107C-4DE1-8BC9-EF20E8D51B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7A19C3-0F1B-4D65-97B4-3EDF63647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F5728A-26FB-4F25-9BFE-E765F3A26C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CDCEB1-C1B0-4197-A93D-8856DB750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9990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BB5A0E-B5AB-460E-A23A-838F521B0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DEE561-4E0E-4E3A-8D29-53281AF7A8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F46C47-FED0-400E-8DA2-C3E328283F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BDB1E1-ADB0-448A-8843-2645FCDE32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5D8BB7-B0E5-4FC8-AC08-99EB865C1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61FA90-B5E8-4F37-87C9-3D4848121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166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ED29E9C-63EF-4F10-BF5D-DA69D30E5F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02CBA6-E186-4374-8C48-B3D133C47C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08F0C5-1A86-4E0E-B087-384A924037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49E150-69EE-48DC-98C9-4C1889E782F2}" type="datetimeFigureOut">
              <a:rPr lang="en-GB" smtClean="0"/>
              <a:t>20/07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D3F7CE-FCD3-466C-BE62-C54FC0B38B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3CAF4E-5D7E-427B-BBA1-F176169EAB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210A5-3861-4AF2-BEBE-CF20FFF5D5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7986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0C0B981-8051-4A07-B70A-1E8BCDDEEE1E}"/>
              </a:ext>
            </a:extLst>
          </p:cNvPr>
          <p:cNvSpPr txBox="1"/>
          <p:nvPr/>
        </p:nvSpPr>
        <p:spPr>
          <a:xfrm>
            <a:off x="2117557" y="661737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lex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o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9A0CE36-D7CD-41E2-B61B-CD50B2996167}"/>
              </a:ext>
            </a:extLst>
          </p:cNvPr>
          <p:cNvSpPr txBox="1"/>
          <p:nvPr/>
        </p:nvSpPr>
        <p:spPr>
          <a:xfrm>
            <a:off x="4904873" y="712706"/>
            <a:ext cx="1207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lex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o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A98787C-8B12-4A2F-8230-8DC715D20BCA}"/>
              </a:ext>
            </a:extLst>
          </p:cNvPr>
          <p:cNvSpPr txBox="1"/>
          <p:nvPr/>
        </p:nvSpPr>
        <p:spPr>
          <a:xfrm>
            <a:off x="7720524" y="692514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lex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o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B64D85F-3498-45F3-A17E-0A305AAEF758}"/>
              </a:ext>
            </a:extLst>
          </p:cNvPr>
          <p:cNvSpPr txBox="1"/>
          <p:nvPr/>
        </p:nvSpPr>
        <p:spPr>
          <a:xfrm>
            <a:off x="8727922" y="683325"/>
            <a:ext cx="1143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Alexa-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ox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697EC1E-C8C9-4A2B-B690-0C416B27CADF}"/>
              </a:ext>
            </a:extLst>
          </p:cNvPr>
          <p:cNvSpPr txBox="1"/>
          <p:nvPr/>
        </p:nvSpPr>
        <p:spPr>
          <a:xfrm rot="-5400000">
            <a:off x="670924" y="2813308"/>
            <a:ext cx="14334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luorescence imagi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26C2A93-946C-4659-B66D-E10A58A1382B}"/>
              </a:ext>
            </a:extLst>
          </p:cNvPr>
          <p:cNvSpPr txBox="1"/>
          <p:nvPr/>
        </p:nvSpPr>
        <p:spPr>
          <a:xfrm rot="-5400000">
            <a:off x="875523" y="5430206"/>
            <a:ext cx="12410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rgan morphology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9FE76A1-CB5B-4996-8598-F4D35D0D2B4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8349" y="2980435"/>
            <a:ext cx="2753328" cy="168053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ECD5DC4-0952-4F57-8683-21E4D53CFAE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8349" y="1089846"/>
            <a:ext cx="2770438" cy="169097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A8CF3F98-BBB4-4FAD-B943-9E5D5F01A5D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8349" y="4860581"/>
            <a:ext cx="2753328" cy="1575989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AD7C117D-87D5-405B-8A83-018BA27B61B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790" y="2948041"/>
            <a:ext cx="2691992" cy="1643097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37AB32B-F1CF-4C03-9494-09F2BDBBC52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790" y="1106147"/>
            <a:ext cx="2655710" cy="1620952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B5C1B78A-564F-4035-B8FF-A9C7FAE7EC00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617" y="4806732"/>
            <a:ext cx="2670269" cy="1629838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5293D98-D421-4F3F-81A6-77D82430124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1151" y="1106147"/>
            <a:ext cx="2655710" cy="162095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B00ACF70-FF39-4AE9-BCDD-23A8F3854600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7241" y="2936419"/>
            <a:ext cx="2619619" cy="1598923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E6E2E65C-6F59-4B0A-B549-C4E063B04BA2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8192" y="4796583"/>
            <a:ext cx="2579851" cy="1574650"/>
          </a:xfrm>
          <a:prstGeom prst="rect">
            <a:avLst/>
          </a:prstGeom>
        </p:spPr>
      </p:pic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DDFD4E0-B98F-490A-9CCA-7F68C6FD154B}"/>
              </a:ext>
            </a:extLst>
          </p:cNvPr>
          <p:cNvCxnSpPr/>
          <p:nvPr/>
        </p:nvCxnSpPr>
        <p:spPr>
          <a:xfrm>
            <a:off x="1859117" y="1709285"/>
            <a:ext cx="0" cy="2394284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7E5BF522-2780-4CBD-B1AB-87EB9EDC3C28}"/>
              </a:ext>
            </a:extLst>
          </p:cNvPr>
          <p:cNvCxnSpPr/>
          <p:nvPr/>
        </p:nvCxnSpPr>
        <p:spPr>
          <a:xfrm>
            <a:off x="1781556" y="4867125"/>
            <a:ext cx="0" cy="1520727"/>
          </a:xfrm>
          <a:prstGeom prst="line">
            <a:avLst/>
          </a:prstGeom>
          <a:ln w="317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Down Arrow 37">
            <a:extLst>
              <a:ext uri="{FF2B5EF4-FFF2-40B4-BE49-F238E27FC236}">
                <a16:creationId xmlns:a16="http://schemas.microsoft.com/office/drawing/2014/main" id="{EE3DADB4-E068-4F5B-85D3-410A8B9BA4EB}"/>
              </a:ext>
            </a:extLst>
          </p:cNvPr>
          <p:cNvSpPr/>
          <p:nvPr/>
        </p:nvSpPr>
        <p:spPr>
          <a:xfrm flipH="1">
            <a:off x="8359725" y="907959"/>
            <a:ext cx="127782" cy="487088"/>
          </a:xfrm>
          <a:prstGeom prst="down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Down Arrow 38">
            <a:extLst>
              <a:ext uri="{FF2B5EF4-FFF2-40B4-BE49-F238E27FC236}">
                <a16:creationId xmlns:a16="http://schemas.microsoft.com/office/drawing/2014/main" id="{9B6BD742-5B76-4A0E-9F90-8038901E0F96}"/>
              </a:ext>
            </a:extLst>
          </p:cNvPr>
          <p:cNvSpPr/>
          <p:nvPr/>
        </p:nvSpPr>
        <p:spPr>
          <a:xfrm>
            <a:off x="8897564" y="896916"/>
            <a:ext cx="152485" cy="504813"/>
          </a:xfrm>
          <a:prstGeom prst="downArrow">
            <a:avLst/>
          </a:pr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Freeform 39">
            <a:extLst>
              <a:ext uri="{FF2B5EF4-FFF2-40B4-BE49-F238E27FC236}">
                <a16:creationId xmlns:a16="http://schemas.microsoft.com/office/drawing/2014/main" id="{BFD96A18-0F97-423A-B7F8-AFB68937B95E}"/>
              </a:ext>
            </a:extLst>
          </p:cNvPr>
          <p:cNvSpPr/>
          <p:nvPr/>
        </p:nvSpPr>
        <p:spPr>
          <a:xfrm>
            <a:off x="8319987" y="5407765"/>
            <a:ext cx="76874" cy="68646"/>
          </a:xfrm>
          <a:custGeom>
            <a:avLst/>
            <a:gdLst>
              <a:gd name="connsiteX0" fmla="*/ 76798 w 76874"/>
              <a:gd name="connsiteY0" fmla="*/ 44516 h 68646"/>
              <a:gd name="connsiteX1" fmla="*/ 29031 w 76874"/>
              <a:gd name="connsiteY1" fmla="*/ 68399 h 68646"/>
              <a:gd name="connsiteX2" fmla="*/ 8559 w 76874"/>
              <a:gd name="connsiteY2" fmla="*/ 54751 h 68646"/>
              <a:gd name="connsiteX3" fmla="*/ 1735 w 76874"/>
              <a:gd name="connsiteY3" fmla="*/ 20632 h 68646"/>
              <a:gd name="connsiteX4" fmla="*/ 39267 w 76874"/>
              <a:gd name="connsiteY4" fmla="*/ 160 h 68646"/>
              <a:gd name="connsiteX5" fmla="*/ 76798 w 76874"/>
              <a:gd name="connsiteY5" fmla="*/ 44516 h 68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6874" h="68646">
                <a:moveTo>
                  <a:pt x="76798" y="44516"/>
                </a:moveTo>
                <a:cubicBezTo>
                  <a:pt x="75092" y="55889"/>
                  <a:pt x="40404" y="66693"/>
                  <a:pt x="29031" y="68399"/>
                </a:cubicBezTo>
                <a:cubicBezTo>
                  <a:pt x="17658" y="70105"/>
                  <a:pt x="13108" y="62712"/>
                  <a:pt x="8559" y="54751"/>
                </a:cubicBezTo>
                <a:cubicBezTo>
                  <a:pt x="4010" y="46790"/>
                  <a:pt x="-3383" y="29730"/>
                  <a:pt x="1735" y="20632"/>
                </a:cubicBezTo>
                <a:cubicBezTo>
                  <a:pt x="6853" y="11534"/>
                  <a:pt x="27325" y="3003"/>
                  <a:pt x="39267" y="160"/>
                </a:cubicBezTo>
                <a:cubicBezTo>
                  <a:pt x="51209" y="-2683"/>
                  <a:pt x="78504" y="33143"/>
                  <a:pt x="76798" y="44516"/>
                </a:cubicBezTo>
                <a:close/>
              </a:path>
            </a:pathLst>
          </a:custGeom>
          <a:noFill/>
          <a:ln w="63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Freeform 40">
            <a:extLst>
              <a:ext uri="{FF2B5EF4-FFF2-40B4-BE49-F238E27FC236}">
                <a16:creationId xmlns:a16="http://schemas.microsoft.com/office/drawing/2014/main" id="{7BA3890D-0B8F-4FCE-9E01-0A1467389956}"/>
              </a:ext>
            </a:extLst>
          </p:cNvPr>
          <p:cNvSpPr/>
          <p:nvPr/>
        </p:nvSpPr>
        <p:spPr>
          <a:xfrm>
            <a:off x="8935369" y="5579929"/>
            <a:ext cx="76874" cy="68646"/>
          </a:xfrm>
          <a:custGeom>
            <a:avLst/>
            <a:gdLst>
              <a:gd name="connsiteX0" fmla="*/ 76798 w 76874"/>
              <a:gd name="connsiteY0" fmla="*/ 44516 h 68646"/>
              <a:gd name="connsiteX1" fmla="*/ 29031 w 76874"/>
              <a:gd name="connsiteY1" fmla="*/ 68399 h 68646"/>
              <a:gd name="connsiteX2" fmla="*/ 8559 w 76874"/>
              <a:gd name="connsiteY2" fmla="*/ 54751 h 68646"/>
              <a:gd name="connsiteX3" fmla="*/ 1735 w 76874"/>
              <a:gd name="connsiteY3" fmla="*/ 20632 h 68646"/>
              <a:gd name="connsiteX4" fmla="*/ 39267 w 76874"/>
              <a:gd name="connsiteY4" fmla="*/ 160 h 68646"/>
              <a:gd name="connsiteX5" fmla="*/ 76798 w 76874"/>
              <a:gd name="connsiteY5" fmla="*/ 44516 h 6864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76874" h="68646">
                <a:moveTo>
                  <a:pt x="76798" y="44516"/>
                </a:moveTo>
                <a:cubicBezTo>
                  <a:pt x="75092" y="55889"/>
                  <a:pt x="40404" y="66693"/>
                  <a:pt x="29031" y="68399"/>
                </a:cubicBezTo>
                <a:cubicBezTo>
                  <a:pt x="17658" y="70105"/>
                  <a:pt x="13108" y="62712"/>
                  <a:pt x="8559" y="54751"/>
                </a:cubicBezTo>
                <a:cubicBezTo>
                  <a:pt x="4010" y="46790"/>
                  <a:pt x="-3383" y="29730"/>
                  <a:pt x="1735" y="20632"/>
                </a:cubicBezTo>
                <a:cubicBezTo>
                  <a:pt x="6853" y="11534"/>
                  <a:pt x="27325" y="3003"/>
                  <a:pt x="39267" y="160"/>
                </a:cubicBezTo>
                <a:cubicBezTo>
                  <a:pt x="51209" y="-2683"/>
                  <a:pt x="78504" y="33143"/>
                  <a:pt x="76798" y="44516"/>
                </a:cubicBezTo>
                <a:close/>
              </a:path>
            </a:pathLst>
          </a:custGeom>
          <a:noFill/>
          <a:ln w="635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60C2379-D80F-4644-A103-9C3600DE54A1}"/>
              </a:ext>
            </a:extLst>
          </p:cNvPr>
          <p:cNvSpPr txBox="1"/>
          <p:nvPr/>
        </p:nvSpPr>
        <p:spPr>
          <a:xfrm>
            <a:off x="8313513" y="5777374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398EDE32-DF68-4302-9DF3-ABA25C61D4F5}"/>
              </a:ext>
            </a:extLst>
          </p:cNvPr>
          <p:cNvCxnSpPr/>
          <p:nvPr/>
        </p:nvCxnSpPr>
        <p:spPr>
          <a:xfrm flipH="1" flipV="1">
            <a:off x="8423616" y="5553316"/>
            <a:ext cx="63891" cy="22405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08575C7C-44C0-4955-B63D-20BE56D5C930}"/>
              </a:ext>
            </a:extLst>
          </p:cNvPr>
          <p:cNvCxnSpPr/>
          <p:nvPr/>
        </p:nvCxnSpPr>
        <p:spPr>
          <a:xfrm flipV="1">
            <a:off x="8639908" y="5665345"/>
            <a:ext cx="295461" cy="26442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449E340-58BB-4A13-8D82-EE215F896D03}"/>
              </a:ext>
            </a:extLst>
          </p:cNvPr>
          <p:cNvSpPr txBox="1"/>
          <p:nvPr/>
        </p:nvSpPr>
        <p:spPr>
          <a:xfrm>
            <a:off x="2462203" y="5301169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bra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ABED6DA-1DAA-49B1-BEFB-C722979B7994}"/>
              </a:ext>
            </a:extLst>
          </p:cNvPr>
          <p:cNvSpPr txBox="1"/>
          <p:nvPr/>
        </p:nvSpPr>
        <p:spPr>
          <a:xfrm>
            <a:off x="2758323" y="5806663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lung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59199DE-A161-462A-B988-B84BDC83DC01}"/>
              </a:ext>
            </a:extLst>
          </p:cNvPr>
          <p:cNvSpPr txBox="1"/>
          <p:nvPr/>
        </p:nvSpPr>
        <p:spPr>
          <a:xfrm>
            <a:off x="3039418" y="4994218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liver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B61979D-8E87-4155-9989-4B28B08A4D37}"/>
              </a:ext>
            </a:extLst>
          </p:cNvPr>
          <p:cNvSpPr txBox="1"/>
          <p:nvPr/>
        </p:nvSpPr>
        <p:spPr>
          <a:xfrm>
            <a:off x="2635470" y="4744014"/>
            <a:ext cx="4651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hear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0EEEE23-2CE7-4EA5-A5F8-9572568CAE2D}"/>
              </a:ext>
            </a:extLst>
          </p:cNvPr>
          <p:cNvSpPr txBox="1"/>
          <p:nvPr/>
        </p:nvSpPr>
        <p:spPr>
          <a:xfrm>
            <a:off x="2045837" y="570185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plee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BF63728-BBA3-4B1C-8B81-6FE47DC96A6B}"/>
              </a:ext>
            </a:extLst>
          </p:cNvPr>
          <p:cNvSpPr txBox="1"/>
          <p:nvPr/>
        </p:nvSpPr>
        <p:spPr>
          <a:xfrm>
            <a:off x="1927068" y="4937813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kidney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BAB2E5-D1DF-4C5C-AF76-19803B41A7BE}"/>
              </a:ext>
            </a:extLst>
          </p:cNvPr>
          <p:cNvSpPr txBox="1"/>
          <p:nvPr/>
        </p:nvSpPr>
        <p:spPr>
          <a:xfrm>
            <a:off x="5442345" y="545563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bra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35ADC6C-FB09-4C2A-89C5-E040895B3617}"/>
              </a:ext>
            </a:extLst>
          </p:cNvPr>
          <p:cNvSpPr txBox="1"/>
          <p:nvPr/>
        </p:nvSpPr>
        <p:spPr>
          <a:xfrm>
            <a:off x="4842533" y="5015807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lung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773B4EB-A695-45A8-8E03-81DDF23C5248}"/>
              </a:ext>
            </a:extLst>
          </p:cNvPr>
          <p:cNvSpPr txBox="1"/>
          <p:nvPr/>
        </p:nvSpPr>
        <p:spPr>
          <a:xfrm>
            <a:off x="4904873" y="5872404"/>
            <a:ext cx="4090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liver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DF4F8D6-5307-41A0-9DB8-7029DD6FD036}"/>
              </a:ext>
            </a:extLst>
          </p:cNvPr>
          <p:cNvSpPr txBox="1"/>
          <p:nvPr/>
        </p:nvSpPr>
        <p:spPr>
          <a:xfrm>
            <a:off x="5410357" y="4805317"/>
            <a:ext cx="4651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hear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4D82E40-4233-4755-B4C3-52A2AA520F5F}"/>
              </a:ext>
            </a:extLst>
          </p:cNvPr>
          <p:cNvSpPr txBox="1"/>
          <p:nvPr/>
        </p:nvSpPr>
        <p:spPr>
          <a:xfrm>
            <a:off x="5896110" y="5035859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splee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86C8739-6C7D-4C33-B029-9CCE1B65D5D0}"/>
              </a:ext>
            </a:extLst>
          </p:cNvPr>
          <p:cNvSpPr txBox="1"/>
          <p:nvPr/>
        </p:nvSpPr>
        <p:spPr>
          <a:xfrm>
            <a:off x="5875549" y="5995515"/>
            <a:ext cx="5277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FF0000"/>
                </a:solidFill>
              </a:rPr>
              <a:t>kidney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2B5C872-D29F-49D7-A68D-61A2C29325E2}"/>
              </a:ext>
            </a:extLst>
          </p:cNvPr>
          <p:cNvSpPr txBox="1"/>
          <p:nvPr/>
        </p:nvSpPr>
        <p:spPr>
          <a:xfrm>
            <a:off x="368183" y="269037"/>
            <a:ext cx="1789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/>
              <a:t>Additional </a:t>
            </a:r>
            <a:r>
              <a:rPr lang="en-GB" b="1" dirty="0"/>
              <a:t>File  6</a:t>
            </a:r>
          </a:p>
        </p:txBody>
      </p:sp>
    </p:spTree>
    <p:extLst>
      <p:ext uri="{BB962C8B-B14F-4D97-AF65-F5344CB8AC3E}">
        <p14:creationId xmlns:p14="http://schemas.microsoft.com/office/powerpoint/2010/main" val="664878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lph, Kate Dr (Sch of Biosci &amp; Med)</dc:creator>
  <cp:lastModifiedBy>Relph, Kate Dr (Sch of Biosci &amp; Med)</cp:lastModifiedBy>
  <cp:revision>1</cp:revision>
  <dcterms:created xsi:type="dcterms:W3CDTF">2021-07-20T08:13:14Z</dcterms:created>
  <dcterms:modified xsi:type="dcterms:W3CDTF">2021-07-20T08:14:14Z</dcterms:modified>
</cp:coreProperties>
</file>